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0107B7-4E43-4DBC-A034-1F9494F8E83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E67621-7520-443A-9F1B-35B72D6BD0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7EF32C-4FCF-4E3F-B1E4-F30B0A5520E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973C5B-F0E8-4979-8352-A2DEA33759A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550DA1-B2C0-4D4A-9B92-019F7501AC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1C87E7-BD88-4DE1-AF94-A2C2CEB276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96E209-7F34-4126-A427-ECA68E42A7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E0004A-2B3E-4BEF-9DD1-A7DC3A50AB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417593-69AB-4CAB-942B-F70E12C060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DB1970-242D-4286-8655-9AC1956826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1F3DDC-20F7-4F24-930F-99BC863A31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73F535-AC74-4835-8D14-71AFD3656F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47EC3D-B3BB-4FC8-9A85-FF8828B3F91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16"/>
          <p:cNvSpPr/>
          <p:nvPr/>
        </p:nvSpPr>
        <p:spPr>
          <a:xfrm>
            <a:off x="152280" y="152280"/>
            <a:ext cx="91440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Canvas 163"/>
          <p:cNvGrpSpPr/>
          <p:nvPr/>
        </p:nvGrpSpPr>
        <p:grpSpPr>
          <a:xfrm>
            <a:off x="1343160" y="1133640"/>
            <a:ext cx="6581520" cy="3362040"/>
            <a:chOff x="1343160" y="1133640"/>
            <a:chExt cx="6581520" cy="3362040"/>
          </a:xfrm>
        </p:grpSpPr>
        <p:sp>
          <p:nvSpPr>
            <p:cNvPr id="43" name="AutoShape 115"/>
            <p:cNvSpPr/>
            <p:nvPr/>
          </p:nvSpPr>
          <p:spPr>
            <a:xfrm>
              <a:off x="1343160" y="1133640"/>
              <a:ext cx="6581520" cy="336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4" name="Group 4"/>
            <p:cNvGrpSpPr/>
            <p:nvPr/>
          </p:nvGrpSpPr>
          <p:grpSpPr>
            <a:xfrm>
              <a:off x="1384200" y="2640960"/>
              <a:ext cx="6440400" cy="681840"/>
              <a:chOff x="1384200" y="2640960"/>
              <a:chExt cx="6440400" cy="681840"/>
            </a:xfrm>
          </p:grpSpPr>
          <p:sp>
            <p:nvSpPr>
              <p:cNvPr id="45" name="Line 5"/>
              <p:cNvSpPr/>
              <p:nvPr/>
            </p:nvSpPr>
            <p:spPr>
              <a:xfrm>
                <a:off x="1384200" y="2640960"/>
                <a:ext cx="6440400" cy="0"/>
              </a:xfrm>
              <a:prstGeom prst="line">
                <a:avLst/>
              </a:prstGeom>
              <a:ln w="76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" name="Line 6"/>
              <p:cNvSpPr/>
              <p:nvPr/>
            </p:nvSpPr>
            <p:spPr>
              <a:xfrm>
                <a:off x="1384200" y="3322800"/>
                <a:ext cx="6440400" cy="0"/>
              </a:xfrm>
              <a:prstGeom prst="line">
                <a:avLst/>
              </a:prstGeom>
              <a:ln w="76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47" name="Text Box 7"/>
            <p:cNvSpPr/>
            <p:nvPr/>
          </p:nvSpPr>
          <p:spPr>
            <a:xfrm>
              <a:off x="1350720" y="2819520"/>
              <a:ext cx="182880" cy="206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8" name="Group 8"/>
            <p:cNvGrpSpPr/>
            <p:nvPr/>
          </p:nvGrpSpPr>
          <p:grpSpPr>
            <a:xfrm>
              <a:off x="2070000" y="2588040"/>
              <a:ext cx="342720" cy="770400"/>
              <a:chOff x="2070000" y="2588040"/>
              <a:chExt cx="342720" cy="770400"/>
            </a:xfrm>
          </p:grpSpPr>
          <p:sp>
            <p:nvSpPr>
              <p:cNvPr id="49" name="Rectangle 9"/>
              <p:cNvSpPr/>
              <p:nvPr/>
            </p:nvSpPr>
            <p:spPr>
              <a:xfrm>
                <a:off x="2070000" y="2642400"/>
                <a:ext cx="342720" cy="664920"/>
              </a:xfrm>
              <a:prstGeom prst="rect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Oval 10"/>
              <p:cNvSpPr/>
              <p:nvPr/>
            </p:nvSpPr>
            <p:spPr>
              <a:xfrm>
                <a:off x="2070000" y="2588040"/>
                <a:ext cx="342720" cy="92520"/>
              </a:xfrm>
              <a:prstGeom prst="ellipse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080" bIns="190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Oval 11"/>
              <p:cNvSpPr/>
              <p:nvPr/>
            </p:nvSpPr>
            <p:spPr>
              <a:xfrm>
                <a:off x="2070000" y="3265920"/>
                <a:ext cx="342720" cy="92520"/>
              </a:xfrm>
              <a:prstGeom prst="ellipse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080" bIns="190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Rectangle 12"/>
              <p:cNvSpPr/>
              <p:nvPr/>
            </p:nvSpPr>
            <p:spPr>
              <a:xfrm>
                <a:off x="2081520" y="3256560"/>
                <a:ext cx="330840" cy="52920"/>
              </a:xfrm>
              <a:prstGeom prst="rect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3" name="Group 13"/>
            <p:cNvGrpSpPr/>
            <p:nvPr/>
          </p:nvGrpSpPr>
          <p:grpSpPr>
            <a:xfrm>
              <a:off x="2527920" y="2588040"/>
              <a:ext cx="342720" cy="770400"/>
              <a:chOff x="2527920" y="2588040"/>
              <a:chExt cx="342720" cy="770400"/>
            </a:xfrm>
          </p:grpSpPr>
          <p:sp>
            <p:nvSpPr>
              <p:cNvPr id="54" name="Rectangle 14"/>
              <p:cNvSpPr/>
              <p:nvPr/>
            </p:nvSpPr>
            <p:spPr>
              <a:xfrm>
                <a:off x="2527920" y="2642400"/>
                <a:ext cx="342720" cy="664920"/>
              </a:xfrm>
              <a:prstGeom prst="rect">
                <a:avLst/>
              </a:prstGeom>
              <a:gradFill rotWithShape="0">
                <a:gsLst>
                  <a:gs pos="0">
                    <a:srgbClr val="b26b8e"/>
                  </a:gs>
                  <a:gs pos="50000">
                    <a:srgbClr val="ff99cc"/>
                  </a:gs>
                  <a:gs pos="100000">
                    <a:srgbClr val="b26b8e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Oval 15"/>
              <p:cNvSpPr/>
              <p:nvPr/>
            </p:nvSpPr>
            <p:spPr>
              <a:xfrm>
                <a:off x="2527920" y="2588040"/>
                <a:ext cx="342720" cy="92520"/>
              </a:xfrm>
              <a:prstGeom prst="ellipse">
                <a:avLst/>
              </a:prstGeom>
              <a:gradFill rotWithShape="0">
                <a:gsLst>
                  <a:gs pos="0">
                    <a:srgbClr val="b26b8e"/>
                  </a:gs>
                  <a:gs pos="50000">
                    <a:srgbClr val="ff99cc"/>
                  </a:gs>
                  <a:gs pos="100000">
                    <a:srgbClr val="b26b8e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080" bIns="190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Oval 16"/>
              <p:cNvSpPr/>
              <p:nvPr/>
            </p:nvSpPr>
            <p:spPr>
              <a:xfrm>
                <a:off x="2527920" y="3265920"/>
                <a:ext cx="342720" cy="92520"/>
              </a:xfrm>
              <a:prstGeom prst="ellipse">
                <a:avLst/>
              </a:prstGeom>
              <a:gradFill rotWithShape="0">
                <a:gsLst>
                  <a:gs pos="0">
                    <a:srgbClr val="b26b8e"/>
                  </a:gs>
                  <a:gs pos="50000">
                    <a:srgbClr val="ff99cc"/>
                  </a:gs>
                  <a:gs pos="100000">
                    <a:srgbClr val="b26b8e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080" bIns="190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Rectangle 17"/>
              <p:cNvSpPr/>
              <p:nvPr/>
            </p:nvSpPr>
            <p:spPr>
              <a:xfrm>
                <a:off x="2539440" y="3256560"/>
                <a:ext cx="330840" cy="52920"/>
              </a:xfrm>
              <a:prstGeom prst="rect">
                <a:avLst/>
              </a:prstGeom>
              <a:gradFill rotWithShape="0">
                <a:gsLst>
                  <a:gs pos="0">
                    <a:srgbClr val="b26b8e"/>
                  </a:gs>
                  <a:gs pos="50000">
                    <a:srgbClr val="ff99cc"/>
                  </a:gs>
                  <a:gs pos="100000">
                    <a:srgbClr val="b26b8e"/>
                  </a:gs>
                </a:gsLst>
                <a:lin ang="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8" name="Group 18"/>
            <p:cNvGrpSpPr/>
            <p:nvPr/>
          </p:nvGrpSpPr>
          <p:grpSpPr>
            <a:xfrm>
              <a:off x="2985120" y="2588040"/>
              <a:ext cx="342720" cy="770400"/>
              <a:chOff x="2985120" y="2588040"/>
              <a:chExt cx="342720" cy="770400"/>
            </a:xfrm>
          </p:grpSpPr>
          <p:sp>
            <p:nvSpPr>
              <p:cNvPr id="59" name="Rectangle 19"/>
              <p:cNvSpPr/>
              <p:nvPr/>
            </p:nvSpPr>
            <p:spPr>
              <a:xfrm>
                <a:off x="2985120" y="2642400"/>
                <a:ext cx="342720" cy="664920"/>
              </a:xfrm>
              <a:prstGeom prst="rect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" name="Oval 20"/>
              <p:cNvSpPr/>
              <p:nvPr/>
            </p:nvSpPr>
            <p:spPr>
              <a:xfrm>
                <a:off x="2985120" y="2588040"/>
                <a:ext cx="342720" cy="92520"/>
              </a:xfrm>
              <a:prstGeom prst="ellipse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080" bIns="190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" name="Oval 21"/>
              <p:cNvSpPr/>
              <p:nvPr/>
            </p:nvSpPr>
            <p:spPr>
              <a:xfrm>
                <a:off x="2985120" y="3265920"/>
                <a:ext cx="342720" cy="92520"/>
              </a:xfrm>
              <a:prstGeom prst="ellipse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080" bIns="190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Rectangle 22"/>
              <p:cNvSpPr/>
              <p:nvPr/>
            </p:nvSpPr>
            <p:spPr>
              <a:xfrm>
                <a:off x="2996640" y="3256560"/>
                <a:ext cx="330840" cy="52920"/>
              </a:xfrm>
              <a:prstGeom prst="rect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3" name="Group 23"/>
            <p:cNvGrpSpPr/>
            <p:nvPr/>
          </p:nvGrpSpPr>
          <p:grpSpPr>
            <a:xfrm>
              <a:off x="3442320" y="2588040"/>
              <a:ext cx="342720" cy="770400"/>
              <a:chOff x="3442320" y="2588040"/>
              <a:chExt cx="342720" cy="770400"/>
            </a:xfrm>
          </p:grpSpPr>
          <p:sp>
            <p:nvSpPr>
              <p:cNvPr id="64" name="Rectangle 24"/>
              <p:cNvSpPr/>
              <p:nvPr/>
            </p:nvSpPr>
            <p:spPr>
              <a:xfrm>
                <a:off x="3442320" y="2642400"/>
                <a:ext cx="342720" cy="664920"/>
              </a:xfrm>
              <a:prstGeom prst="rect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Oval 25"/>
              <p:cNvSpPr/>
              <p:nvPr/>
            </p:nvSpPr>
            <p:spPr>
              <a:xfrm>
                <a:off x="3442320" y="2588040"/>
                <a:ext cx="342720" cy="92520"/>
              </a:xfrm>
              <a:prstGeom prst="ellipse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080" bIns="190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" name="Oval 26"/>
              <p:cNvSpPr/>
              <p:nvPr/>
            </p:nvSpPr>
            <p:spPr>
              <a:xfrm>
                <a:off x="3442320" y="3265920"/>
                <a:ext cx="342720" cy="92520"/>
              </a:xfrm>
              <a:prstGeom prst="ellipse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080" bIns="190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" name="Rectangle 27"/>
              <p:cNvSpPr/>
              <p:nvPr/>
            </p:nvSpPr>
            <p:spPr>
              <a:xfrm>
                <a:off x="3453840" y="3256560"/>
                <a:ext cx="330840" cy="52920"/>
              </a:xfrm>
              <a:prstGeom prst="rect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8" name="Group 28"/>
            <p:cNvGrpSpPr/>
            <p:nvPr/>
          </p:nvGrpSpPr>
          <p:grpSpPr>
            <a:xfrm>
              <a:off x="3899520" y="2588040"/>
              <a:ext cx="342720" cy="770400"/>
              <a:chOff x="3899520" y="2588040"/>
              <a:chExt cx="342720" cy="770400"/>
            </a:xfrm>
          </p:grpSpPr>
          <p:sp>
            <p:nvSpPr>
              <p:cNvPr id="69" name="Rectangle 29"/>
              <p:cNvSpPr/>
              <p:nvPr/>
            </p:nvSpPr>
            <p:spPr>
              <a:xfrm>
                <a:off x="3899520" y="2642400"/>
                <a:ext cx="342720" cy="664920"/>
              </a:xfrm>
              <a:prstGeom prst="rect">
                <a:avLst/>
              </a:prstGeom>
              <a:gradFill rotWithShape="0">
                <a:gsLst>
                  <a:gs pos="0">
                    <a:srgbClr val="ba7095"/>
                  </a:gs>
                  <a:gs pos="50000">
                    <a:srgbClr val="ff99cc"/>
                  </a:gs>
                  <a:gs pos="100000">
                    <a:srgbClr val="ba7095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" name="Oval 30"/>
              <p:cNvSpPr/>
              <p:nvPr/>
            </p:nvSpPr>
            <p:spPr>
              <a:xfrm>
                <a:off x="3899520" y="2588040"/>
                <a:ext cx="342720" cy="92520"/>
              </a:xfrm>
              <a:prstGeom prst="ellipse">
                <a:avLst/>
              </a:prstGeom>
              <a:gradFill rotWithShape="0">
                <a:gsLst>
                  <a:gs pos="0">
                    <a:srgbClr val="ba7095"/>
                  </a:gs>
                  <a:gs pos="50000">
                    <a:srgbClr val="ff99cc"/>
                  </a:gs>
                  <a:gs pos="100000">
                    <a:srgbClr val="ba7095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080" bIns="190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Oval 31"/>
              <p:cNvSpPr/>
              <p:nvPr/>
            </p:nvSpPr>
            <p:spPr>
              <a:xfrm>
                <a:off x="3899520" y="3265920"/>
                <a:ext cx="342720" cy="92520"/>
              </a:xfrm>
              <a:prstGeom prst="ellipse">
                <a:avLst/>
              </a:prstGeom>
              <a:gradFill rotWithShape="0">
                <a:gsLst>
                  <a:gs pos="0">
                    <a:srgbClr val="ba7095"/>
                  </a:gs>
                  <a:gs pos="50000">
                    <a:srgbClr val="ff99cc"/>
                  </a:gs>
                  <a:gs pos="100000">
                    <a:srgbClr val="ba7095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080" bIns="190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" name="Rectangle 32"/>
              <p:cNvSpPr/>
              <p:nvPr/>
            </p:nvSpPr>
            <p:spPr>
              <a:xfrm>
                <a:off x="3911040" y="3256560"/>
                <a:ext cx="330840" cy="52920"/>
              </a:xfrm>
              <a:prstGeom prst="rect">
                <a:avLst/>
              </a:prstGeom>
              <a:gradFill rotWithShape="0">
                <a:gsLst>
                  <a:gs pos="0">
                    <a:srgbClr val="ba7095"/>
                  </a:gs>
                  <a:gs pos="50000">
                    <a:srgbClr val="ff99cc"/>
                  </a:gs>
                  <a:gs pos="100000">
                    <a:srgbClr val="ba7095"/>
                  </a:gs>
                </a:gsLst>
                <a:lin ang="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3" name="Group 33"/>
            <p:cNvGrpSpPr/>
            <p:nvPr/>
          </p:nvGrpSpPr>
          <p:grpSpPr>
            <a:xfrm>
              <a:off x="4357440" y="2588040"/>
              <a:ext cx="342000" cy="770400"/>
              <a:chOff x="4357440" y="2588040"/>
              <a:chExt cx="342000" cy="770400"/>
            </a:xfrm>
          </p:grpSpPr>
          <p:sp>
            <p:nvSpPr>
              <p:cNvPr id="74" name="Rectangle 34"/>
              <p:cNvSpPr/>
              <p:nvPr/>
            </p:nvSpPr>
            <p:spPr>
              <a:xfrm>
                <a:off x="4357440" y="2642400"/>
                <a:ext cx="342000" cy="664920"/>
              </a:xfrm>
              <a:prstGeom prst="rect">
                <a:avLst/>
              </a:prstGeom>
              <a:gradFill rotWithShape="0">
                <a:gsLst>
                  <a:gs pos="0">
                    <a:srgbClr val="ba7095"/>
                  </a:gs>
                  <a:gs pos="50000">
                    <a:srgbClr val="ff99cc"/>
                  </a:gs>
                  <a:gs pos="100000">
                    <a:srgbClr val="ba7095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" name="Oval 35"/>
              <p:cNvSpPr/>
              <p:nvPr/>
            </p:nvSpPr>
            <p:spPr>
              <a:xfrm>
                <a:off x="4357440" y="2588040"/>
                <a:ext cx="342000" cy="92520"/>
              </a:xfrm>
              <a:prstGeom prst="ellipse">
                <a:avLst/>
              </a:prstGeom>
              <a:gradFill rotWithShape="0">
                <a:gsLst>
                  <a:gs pos="0">
                    <a:srgbClr val="ba7095"/>
                  </a:gs>
                  <a:gs pos="50000">
                    <a:srgbClr val="ff99cc"/>
                  </a:gs>
                  <a:gs pos="100000">
                    <a:srgbClr val="ba7095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080" bIns="190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" name="Oval 36"/>
              <p:cNvSpPr/>
              <p:nvPr/>
            </p:nvSpPr>
            <p:spPr>
              <a:xfrm>
                <a:off x="4357440" y="3265920"/>
                <a:ext cx="342000" cy="92520"/>
              </a:xfrm>
              <a:prstGeom prst="ellipse">
                <a:avLst/>
              </a:prstGeom>
              <a:gradFill rotWithShape="0">
                <a:gsLst>
                  <a:gs pos="0">
                    <a:srgbClr val="ba7095"/>
                  </a:gs>
                  <a:gs pos="50000">
                    <a:srgbClr val="ff99cc"/>
                  </a:gs>
                  <a:gs pos="100000">
                    <a:srgbClr val="ba7095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080" bIns="190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" name="Rectangle 37"/>
              <p:cNvSpPr/>
              <p:nvPr/>
            </p:nvSpPr>
            <p:spPr>
              <a:xfrm>
                <a:off x="4368960" y="3256560"/>
                <a:ext cx="330120" cy="52920"/>
              </a:xfrm>
              <a:prstGeom prst="rect">
                <a:avLst/>
              </a:prstGeom>
              <a:gradFill rotWithShape="0">
                <a:gsLst>
                  <a:gs pos="0">
                    <a:srgbClr val="ba7095"/>
                  </a:gs>
                  <a:gs pos="50000">
                    <a:srgbClr val="ff99cc"/>
                  </a:gs>
                  <a:gs pos="100000">
                    <a:srgbClr val="ba7095"/>
                  </a:gs>
                </a:gsLst>
                <a:lin ang="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8" name="Group 38"/>
            <p:cNvGrpSpPr/>
            <p:nvPr/>
          </p:nvGrpSpPr>
          <p:grpSpPr>
            <a:xfrm>
              <a:off x="4813920" y="2588040"/>
              <a:ext cx="342720" cy="770400"/>
              <a:chOff x="4813920" y="2588040"/>
              <a:chExt cx="342720" cy="770400"/>
            </a:xfrm>
          </p:grpSpPr>
          <p:sp>
            <p:nvSpPr>
              <p:cNvPr id="79" name="Rectangle 39"/>
              <p:cNvSpPr/>
              <p:nvPr/>
            </p:nvSpPr>
            <p:spPr>
              <a:xfrm>
                <a:off x="4813920" y="2642400"/>
                <a:ext cx="342720" cy="664920"/>
              </a:xfrm>
              <a:prstGeom prst="rect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" name="Oval 40"/>
              <p:cNvSpPr/>
              <p:nvPr/>
            </p:nvSpPr>
            <p:spPr>
              <a:xfrm>
                <a:off x="4813920" y="2588040"/>
                <a:ext cx="342720" cy="92520"/>
              </a:xfrm>
              <a:prstGeom prst="ellipse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080" bIns="190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" name="Oval 41"/>
              <p:cNvSpPr/>
              <p:nvPr/>
            </p:nvSpPr>
            <p:spPr>
              <a:xfrm>
                <a:off x="4813920" y="3265920"/>
                <a:ext cx="342720" cy="92520"/>
              </a:xfrm>
              <a:prstGeom prst="ellipse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080" bIns="190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Rectangle 42"/>
              <p:cNvSpPr/>
              <p:nvPr/>
            </p:nvSpPr>
            <p:spPr>
              <a:xfrm>
                <a:off x="4825440" y="3256560"/>
                <a:ext cx="330840" cy="52920"/>
              </a:xfrm>
              <a:prstGeom prst="rect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3" name="Group 43"/>
            <p:cNvGrpSpPr/>
            <p:nvPr/>
          </p:nvGrpSpPr>
          <p:grpSpPr>
            <a:xfrm>
              <a:off x="5271840" y="2588040"/>
              <a:ext cx="342720" cy="770400"/>
              <a:chOff x="5271840" y="2588040"/>
              <a:chExt cx="342720" cy="770400"/>
            </a:xfrm>
          </p:grpSpPr>
          <p:sp>
            <p:nvSpPr>
              <p:cNvPr id="84" name="Rectangle 44"/>
              <p:cNvSpPr/>
              <p:nvPr/>
            </p:nvSpPr>
            <p:spPr>
              <a:xfrm>
                <a:off x="5271840" y="2642400"/>
                <a:ext cx="342720" cy="664920"/>
              </a:xfrm>
              <a:prstGeom prst="rect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Oval 45"/>
              <p:cNvSpPr/>
              <p:nvPr/>
            </p:nvSpPr>
            <p:spPr>
              <a:xfrm>
                <a:off x="5271840" y="2588040"/>
                <a:ext cx="342720" cy="92520"/>
              </a:xfrm>
              <a:prstGeom prst="ellipse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080" bIns="190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" name="Oval 46"/>
              <p:cNvSpPr/>
              <p:nvPr/>
            </p:nvSpPr>
            <p:spPr>
              <a:xfrm>
                <a:off x="5271840" y="3265920"/>
                <a:ext cx="342720" cy="92520"/>
              </a:xfrm>
              <a:prstGeom prst="ellipse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080" bIns="190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" name="Rectangle 47"/>
              <p:cNvSpPr/>
              <p:nvPr/>
            </p:nvSpPr>
            <p:spPr>
              <a:xfrm>
                <a:off x="5283360" y="3256560"/>
                <a:ext cx="330840" cy="52920"/>
              </a:xfrm>
              <a:prstGeom prst="rect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8" name="Group 48"/>
            <p:cNvGrpSpPr/>
            <p:nvPr/>
          </p:nvGrpSpPr>
          <p:grpSpPr>
            <a:xfrm>
              <a:off x="5729040" y="2588040"/>
              <a:ext cx="343440" cy="770400"/>
              <a:chOff x="5729040" y="2588040"/>
              <a:chExt cx="343440" cy="770400"/>
            </a:xfrm>
          </p:grpSpPr>
          <p:sp>
            <p:nvSpPr>
              <p:cNvPr id="89" name="Rectangle 49"/>
              <p:cNvSpPr/>
              <p:nvPr/>
            </p:nvSpPr>
            <p:spPr>
              <a:xfrm>
                <a:off x="5729040" y="2642400"/>
                <a:ext cx="343440" cy="664920"/>
              </a:xfrm>
              <a:prstGeom prst="rect">
                <a:avLst/>
              </a:prstGeom>
              <a:gradFill rotWithShape="0">
                <a:gsLst>
                  <a:gs pos="0">
                    <a:srgbClr val="ba7095"/>
                  </a:gs>
                  <a:gs pos="50000">
                    <a:srgbClr val="ff99cc"/>
                  </a:gs>
                  <a:gs pos="100000">
                    <a:srgbClr val="ba7095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" name="Oval 50"/>
              <p:cNvSpPr/>
              <p:nvPr/>
            </p:nvSpPr>
            <p:spPr>
              <a:xfrm>
                <a:off x="5729040" y="2588040"/>
                <a:ext cx="343440" cy="92520"/>
              </a:xfrm>
              <a:prstGeom prst="ellipse">
                <a:avLst/>
              </a:prstGeom>
              <a:gradFill rotWithShape="0">
                <a:gsLst>
                  <a:gs pos="0">
                    <a:srgbClr val="ba7095"/>
                  </a:gs>
                  <a:gs pos="50000">
                    <a:srgbClr val="ff99cc"/>
                  </a:gs>
                  <a:gs pos="100000">
                    <a:srgbClr val="ba7095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080" bIns="190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" name="Oval 51"/>
              <p:cNvSpPr/>
              <p:nvPr/>
            </p:nvSpPr>
            <p:spPr>
              <a:xfrm>
                <a:off x="5729040" y="3265920"/>
                <a:ext cx="343440" cy="92520"/>
              </a:xfrm>
              <a:prstGeom prst="ellipse">
                <a:avLst/>
              </a:prstGeom>
              <a:gradFill rotWithShape="0">
                <a:gsLst>
                  <a:gs pos="0">
                    <a:srgbClr val="ba7095"/>
                  </a:gs>
                  <a:gs pos="50000">
                    <a:srgbClr val="ff99cc"/>
                  </a:gs>
                  <a:gs pos="100000">
                    <a:srgbClr val="ba7095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080" bIns="190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Rectangle 52"/>
              <p:cNvSpPr/>
              <p:nvPr/>
            </p:nvSpPr>
            <p:spPr>
              <a:xfrm>
                <a:off x="5740920" y="3256560"/>
                <a:ext cx="331560" cy="52920"/>
              </a:xfrm>
              <a:prstGeom prst="rect">
                <a:avLst/>
              </a:prstGeom>
              <a:gradFill rotWithShape="0">
                <a:gsLst>
                  <a:gs pos="0">
                    <a:srgbClr val="ba7095"/>
                  </a:gs>
                  <a:gs pos="50000">
                    <a:srgbClr val="ff99cc"/>
                  </a:gs>
                  <a:gs pos="100000">
                    <a:srgbClr val="ba7095"/>
                  </a:gs>
                </a:gsLst>
                <a:lin ang="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93" name="Group 53"/>
            <p:cNvGrpSpPr/>
            <p:nvPr/>
          </p:nvGrpSpPr>
          <p:grpSpPr>
            <a:xfrm>
              <a:off x="6185520" y="2588040"/>
              <a:ext cx="343440" cy="770400"/>
              <a:chOff x="6185520" y="2588040"/>
              <a:chExt cx="343440" cy="770400"/>
            </a:xfrm>
          </p:grpSpPr>
          <p:sp>
            <p:nvSpPr>
              <p:cNvPr id="94" name="Rectangle 54"/>
              <p:cNvSpPr/>
              <p:nvPr/>
            </p:nvSpPr>
            <p:spPr>
              <a:xfrm>
                <a:off x="6185520" y="2642400"/>
                <a:ext cx="343440" cy="664920"/>
              </a:xfrm>
              <a:prstGeom prst="rect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Oval 55"/>
              <p:cNvSpPr/>
              <p:nvPr/>
            </p:nvSpPr>
            <p:spPr>
              <a:xfrm>
                <a:off x="6185520" y="2588040"/>
                <a:ext cx="343440" cy="92520"/>
              </a:xfrm>
              <a:prstGeom prst="ellipse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080" bIns="190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" name="Oval 56"/>
              <p:cNvSpPr/>
              <p:nvPr/>
            </p:nvSpPr>
            <p:spPr>
              <a:xfrm>
                <a:off x="6185520" y="3265920"/>
                <a:ext cx="343440" cy="92520"/>
              </a:xfrm>
              <a:prstGeom prst="ellipse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080" bIns="190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" name="Rectangle 57"/>
              <p:cNvSpPr/>
              <p:nvPr/>
            </p:nvSpPr>
            <p:spPr>
              <a:xfrm>
                <a:off x="6197400" y="3256560"/>
                <a:ext cx="331560" cy="52920"/>
              </a:xfrm>
              <a:prstGeom prst="rect">
                <a:avLst/>
              </a:prstGeom>
              <a:gradFill rotWithShape="0">
                <a:gsLst>
                  <a:gs pos="0">
                    <a:srgbClr val="aa6688"/>
                  </a:gs>
                  <a:gs pos="50000">
                    <a:srgbClr val="ff99cc"/>
                  </a:gs>
                  <a:gs pos="100000">
                    <a:srgbClr val="aa6688"/>
                  </a:gs>
                </a:gsLst>
                <a:lin ang="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98" name="Text Box 58"/>
            <p:cNvSpPr/>
            <p:nvPr/>
          </p:nvSpPr>
          <p:spPr>
            <a:xfrm>
              <a:off x="6915240" y="2763000"/>
              <a:ext cx="981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lasma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embrane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Text Box 59"/>
            <p:cNvSpPr/>
            <p:nvPr/>
          </p:nvSpPr>
          <p:spPr>
            <a:xfrm>
              <a:off x="2109600" y="3909960"/>
              <a:ext cx="236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Text Box 60"/>
            <p:cNvSpPr/>
            <p:nvPr/>
          </p:nvSpPr>
          <p:spPr>
            <a:xfrm>
              <a:off x="6429240" y="3464280"/>
              <a:ext cx="253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Text Box 61"/>
            <p:cNvSpPr/>
            <p:nvPr/>
          </p:nvSpPr>
          <p:spPr>
            <a:xfrm>
              <a:off x="2135160" y="2881440"/>
              <a:ext cx="177120" cy="27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I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Text Box 62"/>
            <p:cNvSpPr/>
            <p:nvPr/>
          </p:nvSpPr>
          <p:spPr>
            <a:xfrm>
              <a:off x="2536920" y="2881440"/>
              <a:ext cx="277560" cy="27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II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Text Box 63"/>
            <p:cNvSpPr/>
            <p:nvPr/>
          </p:nvSpPr>
          <p:spPr>
            <a:xfrm>
              <a:off x="2972520" y="2881440"/>
              <a:ext cx="327960" cy="27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III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Text Box 64"/>
            <p:cNvSpPr/>
            <p:nvPr/>
          </p:nvSpPr>
          <p:spPr>
            <a:xfrm>
              <a:off x="3412440" y="2881440"/>
              <a:ext cx="346320" cy="27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IV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Text Box 65"/>
            <p:cNvSpPr/>
            <p:nvPr/>
          </p:nvSpPr>
          <p:spPr>
            <a:xfrm>
              <a:off x="3898440" y="2881440"/>
              <a:ext cx="295920" cy="27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V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Text Box 66"/>
            <p:cNvSpPr/>
            <p:nvPr/>
          </p:nvSpPr>
          <p:spPr>
            <a:xfrm>
              <a:off x="4321800" y="2881440"/>
              <a:ext cx="346320" cy="27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VI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Text Box 67"/>
            <p:cNvSpPr/>
            <p:nvPr/>
          </p:nvSpPr>
          <p:spPr>
            <a:xfrm>
              <a:off x="4734720" y="2881440"/>
              <a:ext cx="396720" cy="27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VII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Text Box 68"/>
            <p:cNvSpPr/>
            <p:nvPr/>
          </p:nvSpPr>
          <p:spPr>
            <a:xfrm>
              <a:off x="5149800" y="2891160"/>
              <a:ext cx="496800" cy="27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 </a:t>
              </a: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VIII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Text Box 69"/>
            <p:cNvSpPr/>
            <p:nvPr/>
          </p:nvSpPr>
          <p:spPr>
            <a:xfrm>
              <a:off x="5704560" y="2891160"/>
              <a:ext cx="346320" cy="27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IX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Text Box 70"/>
            <p:cNvSpPr/>
            <p:nvPr/>
          </p:nvSpPr>
          <p:spPr>
            <a:xfrm>
              <a:off x="6188400" y="2891160"/>
              <a:ext cx="295920" cy="27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X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Text Box 71"/>
            <p:cNvSpPr/>
            <p:nvPr/>
          </p:nvSpPr>
          <p:spPr>
            <a:xfrm>
              <a:off x="6933240" y="2396520"/>
              <a:ext cx="858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eriplasm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Text Box 72"/>
            <p:cNvSpPr/>
            <p:nvPr/>
          </p:nvSpPr>
          <p:spPr>
            <a:xfrm>
              <a:off x="6914520" y="3298680"/>
              <a:ext cx="906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ytoplasm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Text Box 73"/>
            <p:cNvSpPr/>
            <p:nvPr/>
          </p:nvSpPr>
          <p:spPr>
            <a:xfrm>
              <a:off x="2107440" y="3215520"/>
              <a:ext cx="3250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Text Box 74"/>
            <p:cNvSpPr/>
            <p:nvPr/>
          </p:nvSpPr>
          <p:spPr>
            <a:xfrm>
              <a:off x="2107440" y="2670120"/>
              <a:ext cx="3650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8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Text Box 75"/>
            <p:cNvSpPr/>
            <p:nvPr/>
          </p:nvSpPr>
          <p:spPr>
            <a:xfrm>
              <a:off x="2593440" y="3215520"/>
              <a:ext cx="376200" cy="204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000" rIns="63000" tIns="31680" bIns="316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9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Text Box 76"/>
            <p:cNvSpPr/>
            <p:nvPr/>
          </p:nvSpPr>
          <p:spPr>
            <a:xfrm>
              <a:off x="2593440" y="2670120"/>
              <a:ext cx="3765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69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Text Box 77"/>
            <p:cNvSpPr/>
            <p:nvPr/>
          </p:nvSpPr>
          <p:spPr>
            <a:xfrm>
              <a:off x="3025800" y="3215520"/>
              <a:ext cx="4417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9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Text Box 78"/>
            <p:cNvSpPr/>
            <p:nvPr/>
          </p:nvSpPr>
          <p:spPr>
            <a:xfrm>
              <a:off x="2971800" y="2670120"/>
              <a:ext cx="3776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1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Text Box 79"/>
            <p:cNvSpPr/>
            <p:nvPr/>
          </p:nvSpPr>
          <p:spPr>
            <a:xfrm>
              <a:off x="3458520" y="2670120"/>
              <a:ext cx="2959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2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Text Box 80"/>
            <p:cNvSpPr/>
            <p:nvPr/>
          </p:nvSpPr>
          <p:spPr>
            <a:xfrm>
              <a:off x="3458520" y="3215520"/>
              <a:ext cx="2959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4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Text Box 81"/>
            <p:cNvSpPr/>
            <p:nvPr/>
          </p:nvSpPr>
          <p:spPr>
            <a:xfrm>
              <a:off x="3890520" y="3215520"/>
              <a:ext cx="3625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5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Text Box 82"/>
            <p:cNvSpPr/>
            <p:nvPr/>
          </p:nvSpPr>
          <p:spPr>
            <a:xfrm>
              <a:off x="3890520" y="2670120"/>
              <a:ext cx="3625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76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Text Box 83"/>
            <p:cNvSpPr/>
            <p:nvPr/>
          </p:nvSpPr>
          <p:spPr>
            <a:xfrm>
              <a:off x="4375800" y="2670120"/>
              <a:ext cx="461520" cy="177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000" rIns="63000" tIns="31680" bIns="316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86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Text Box 84"/>
            <p:cNvSpPr/>
            <p:nvPr/>
          </p:nvSpPr>
          <p:spPr>
            <a:xfrm>
              <a:off x="4375800" y="3215520"/>
              <a:ext cx="586080" cy="204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000" rIns="63000" tIns="31680" bIns="316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Text Box 85"/>
            <p:cNvSpPr/>
            <p:nvPr/>
          </p:nvSpPr>
          <p:spPr>
            <a:xfrm>
              <a:off x="4807800" y="3215520"/>
              <a:ext cx="3247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1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Text Box 86"/>
            <p:cNvSpPr/>
            <p:nvPr/>
          </p:nvSpPr>
          <p:spPr>
            <a:xfrm>
              <a:off x="4807800" y="2670120"/>
              <a:ext cx="3247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3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Text Box 87"/>
            <p:cNvSpPr/>
            <p:nvPr/>
          </p:nvSpPr>
          <p:spPr>
            <a:xfrm>
              <a:off x="5293800" y="2670120"/>
              <a:ext cx="415080" cy="177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000" rIns="63000" tIns="31680" bIns="316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5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Text Box 88"/>
            <p:cNvSpPr/>
            <p:nvPr/>
          </p:nvSpPr>
          <p:spPr>
            <a:xfrm>
              <a:off x="5293800" y="3215520"/>
              <a:ext cx="415080" cy="204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000" rIns="63000" tIns="31680" bIns="316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7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Text Box 89"/>
            <p:cNvSpPr/>
            <p:nvPr/>
          </p:nvSpPr>
          <p:spPr>
            <a:xfrm>
              <a:off x="5726520" y="3215520"/>
              <a:ext cx="3621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8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Text Box 90"/>
            <p:cNvSpPr/>
            <p:nvPr/>
          </p:nvSpPr>
          <p:spPr>
            <a:xfrm>
              <a:off x="5726520" y="2670120"/>
              <a:ext cx="3621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40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Text Box 91"/>
            <p:cNvSpPr/>
            <p:nvPr/>
          </p:nvSpPr>
          <p:spPr>
            <a:xfrm>
              <a:off x="6212880" y="3215520"/>
              <a:ext cx="491760" cy="204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000" rIns="63000" tIns="31680" bIns="316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436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Text Box 92"/>
            <p:cNvSpPr/>
            <p:nvPr/>
          </p:nvSpPr>
          <p:spPr>
            <a:xfrm>
              <a:off x="6212880" y="2670120"/>
              <a:ext cx="49176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000" rIns="63000" tIns="31680" bIns="316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41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Text Box 93"/>
            <p:cNvSpPr/>
            <p:nvPr/>
          </p:nvSpPr>
          <p:spPr>
            <a:xfrm>
              <a:off x="2025720" y="4155480"/>
              <a:ext cx="689040" cy="200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9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Loop No. 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Text Box 94"/>
            <p:cNvSpPr/>
            <p:nvPr/>
          </p:nvSpPr>
          <p:spPr>
            <a:xfrm>
              <a:off x="2140200" y="1133640"/>
              <a:ext cx="689040" cy="200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9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Loop No. 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Text Box 95"/>
            <p:cNvSpPr/>
            <p:nvPr/>
          </p:nvSpPr>
          <p:spPr>
            <a:xfrm>
              <a:off x="2698200" y="3452040"/>
              <a:ext cx="689040" cy="200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9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Loop No. 3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Text Box 96"/>
            <p:cNvSpPr/>
            <p:nvPr/>
          </p:nvSpPr>
          <p:spPr>
            <a:xfrm>
              <a:off x="3141360" y="2294280"/>
              <a:ext cx="689040" cy="200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9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Loop No. 4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Text Box 97"/>
            <p:cNvSpPr/>
            <p:nvPr/>
          </p:nvSpPr>
          <p:spPr>
            <a:xfrm>
              <a:off x="3577680" y="3641760"/>
              <a:ext cx="689040" cy="200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9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Loop No. 5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Text Box 98"/>
            <p:cNvSpPr/>
            <p:nvPr/>
          </p:nvSpPr>
          <p:spPr>
            <a:xfrm>
              <a:off x="4595040" y="3464640"/>
              <a:ext cx="689040" cy="200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9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Loop No. 7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Text Box 99"/>
            <p:cNvSpPr/>
            <p:nvPr/>
          </p:nvSpPr>
          <p:spPr>
            <a:xfrm>
              <a:off x="4624200" y="1139040"/>
              <a:ext cx="689040" cy="200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9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Loop No. 8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Text Box 100"/>
            <p:cNvSpPr/>
            <p:nvPr/>
          </p:nvSpPr>
          <p:spPr>
            <a:xfrm>
              <a:off x="5451480" y="3461400"/>
              <a:ext cx="689040" cy="200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9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Loop No. 9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Text Box 101"/>
            <p:cNvSpPr/>
            <p:nvPr/>
          </p:nvSpPr>
          <p:spPr>
            <a:xfrm>
              <a:off x="5896440" y="2143800"/>
              <a:ext cx="753120" cy="200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9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Loop No. 1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Text Box 102"/>
            <p:cNvSpPr/>
            <p:nvPr/>
          </p:nvSpPr>
          <p:spPr>
            <a:xfrm>
              <a:off x="6134760" y="3607560"/>
              <a:ext cx="721080" cy="200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9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Loop No 1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Freeform 103"/>
            <p:cNvSpPr/>
            <p:nvPr/>
          </p:nvSpPr>
          <p:spPr>
            <a:xfrm>
              <a:off x="1965240" y="3358080"/>
              <a:ext cx="258840" cy="603000"/>
            </a:xfrm>
            <a:custGeom>
              <a:avLst/>
              <a:gdLst/>
              <a:ahLst/>
              <a:rect l="l" t="t" r="r" b="b"/>
              <a:pathLst>
                <a:path w="217" h="552">
                  <a:moveTo>
                    <a:pt x="216" y="0"/>
                  </a:moveTo>
                  <a:cubicBezTo>
                    <a:pt x="199" y="50"/>
                    <a:pt x="217" y="101"/>
                    <a:pt x="160" y="120"/>
                  </a:cubicBezTo>
                  <a:cubicBezTo>
                    <a:pt x="118" y="162"/>
                    <a:pt x="84" y="213"/>
                    <a:pt x="56" y="264"/>
                  </a:cubicBezTo>
                  <a:cubicBezTo>
                    <a:pt x="36" y="300"/>
                    <a:pt x="13" y="322"/>
                    <a:pt x="0" y="360"/>
                  </a:cubicBezTo>
                  <a:cubicBezTo>
                    <a:pt x="7" y="401"/>
                    <a:pt x="0" y="427"/>
                    <a:pt x="40" y="440"/>
                  </a:cubicBezTo>
                  <a:cubicBezTo>
                    <a:pt x="55" y="455"/>
                    <a:pt x="73" y="465"/>
                    <a:pt x="88" y="480"/>
                  </a:cubicBezTo>
                  <a:cubicBezTo>
                    <a:pt x="141" y="533"/>
                    <a:pt x="64" y="477"/>
                    <a:pt x="128" y="520"/>
                  </a:cubicBezTo>
                  <a:cubicBezTo>
                    <a:pt x="146" y="547"/>
                    <a:pt x="137" y="537"/>
                    <a:pt x="152" y="552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Freeform 104"/>
            <p:cNvSpPr/>
            <p:nvPr/>
          </p:nvSpPr>
          <p:spPr>
            <a:xfrm>
              <a:off x="1864440" y="1407240"/>
              <a:ext cx="1146600" cy="1233720"/>
            </a:xfrm>
            <a:custGeom>
              <a:avLst/>
              <a:gdLst/>
              <a:ahLst/>
              <a:rect l="l" t="t" r="r" b="b"/>
              <a:pathLst>
                <a:path w="963" h="1128">
                  <a:moveTo>
                    <a:pt x="301" y="1120"/>
                  </a:moveTo>
                  <a:cubicBezTo>
                    <a:pt x="304" y="1112"/>
                    <a:pt x="309" y="1104"/>
                    <a:pt x="309" y="1096"/>
                  </a:cubicBezTo>
                  <a:cubicBezTo>
                    <a:pt x="309" y="912"/>
                    <a:pt x="311" y="976"/>
                    <a:pt x="293" y="880"/>
                  </a:cubicBezTo>
                  <a:cubicBezTo>
                    <a:pt x="293" y="879"/>
                    <a:pt x="285" y="818"/>
                    <a:pt x="277" y="808"/>
                  </a:cubicBezTo>
                  <a:cubicBezTo>
                    <a:pt x="264" y="792"/>
                    <a:pt x="244" y="783"/>
                    <a:pt x="229" y="768"/>
                  </a:cubicBezTo>
                  <a:cubicBezTo>
                    <a:pt x="219" y="739"/>
                    <a:pt x="183" y="705"/>
                    <a:pt x="157" y="688"/>
                  </a:cubicBezTo>
                  <a:cubicBezTo>
                    <a:pt x="139" y="660"/>
                    <a:pt x="121" y="642"/>
                    <a:pt x="93" y="624"/>
                  </a:cubicBezTo>
                  <a:cubicBezTo>
                    <a:pt x="83" y="593"/>
                    <a:pt x="58" y="581"/>
                    <a:pt x="45" y="552"/>
                  </a:cubicBezTo>
                  <a:cubicBezTo>
                    <a:pt x="38" y="537"/>
                    <a:pt x="34" y="520"/>
                    <a:pt x="29" y="504"/>
                  </a:cubicBezTo>
                  <a:cubicBezTo>
                    <a:pt x="26" y="496"/>
                    <a:pt x="21" y="480"/>
                    <a:pt x="21" y="480"/>
                  </a:cubicBezTo>
                  <a:cubicBezTo>
                    <a:pt x="25" y="357"/>
                    <a:pt x="0" y="231"/>
                    <a:pt x="69" y="128"/>
                  </a:cubicBezTo>
                  <a:cubicBezTo>
                    <a:pt x="95" y="89"/>
                    <a:pt x="138" y="43"/>
                    <a:pt x="181" y="24"/>
                  </a:cubicBezTo>
                  <a:cubicBezTo>
                    <a:pt x="196" y="17"/>
                    <a:pt x="213" y="13"/>
                    <a:pt x="229" y="8"/>
                  </a:cubicBezTo>
                  <a:cubicBezTo>
                    <a:pt x="237" y="5"/>
                    <a:pt x="253" y="0"/>
                    <a:pt x="253" y="0"/>
                  </a:cubicBezTo>
                  <a:cubicBezTo>
                    <a:pt x="424" y="5"/>
                    <a:pt x="550" y="16"/>
                    <a:pt x="709" y="32"/>
                  </a:cubicBezTo>
                  <a:cubicBezTo>
                    <a:pt x="766" y="51"/>
                    <a:pt x="743" y="39"/>
                    <a:pt x="781" y="64"/>
                  </a:cubicBezTo>
                  <a:cubicBezTo>
                    <a:pt x="824" y="128"/>
                    <a:pt x="768" y="51"/>
                    <a:pt x="821" y="104"/>
                  </a:cubicBezTo>
                  <a:cubicBezTo>
                    <a:pt x="845" y="128"/>
                    <a:pt x="855" y="156"/>
                    <a:pt x="885" y="176"/>
                  </a:cubicBezTo>
                  <a:cubicBezTo>
                    <a:pt x="908" y="211"/>
                    <a:pt x="934" y="238"/>
                    <a:pt x="957" y="272"/>
                  </a:cubicBezTo>
                  <a:cubicBezTo>
                    <a:pt x="954" y="309"/>
                    <a:pt x="963" y="349"/>
                    <a:pt x="949" y="384"/>
                  </a:cubicBezTo>
                  <a:cubicBezTo>
                    <a:pt x="944" y="397"/>
                    <a:pt x="922" y="390"/>
                    <a:pt x="909" y="392"/>
                  </a:cubicBezTo>
                  <a:cubicBezTo>
                    <a:pt x="880" y="396"/>
                    <a:pt x="850" y="398"/>
                    <a:pt x="821" y="400"/>
                  </a:cubicBezTo>
                  <a:cubicBezTo>
                    <a:pt x="762" y="404"/>
                    <a:pt x="704" y="405"/>
                    <a:pt x="645" y="408"/>
                  </a:cubicBezTo>
                  <a:cubicBezTo>
                    <a:pt x="576" y="425"/>
                    <a:pt x="542" y="397"/>
                    <a:pt x="517" y="472"/>
                  </a:cubicBezTo>
                  <a:cubicBezTo>
                    <a:pt x="521" y="520"/>
                    <a:pt x="511" y="573"/>
                    <a:pt x="533" y="616"/>
                  </a:cubicBezTo>
                  <a:cubicBezTo>
                    <a:pt x="539" y="628"/>
                    <a:pt x="570" y="637"/>
                    <a:pt x="581" y="640"/>
                  </a:cubicBezTo>
                  <a:cubicBezTo>
                    <a:pt x="629" y="654"/>
                    <a:pt x="678" y="656"/>
                    <a:pt x="725" y="672"/>
                  </a:cubicBezTo>
                  <a:cubicBezTo>
                    <a:pt x="762" y="684"/>
                    <a:pt x="800" y="692"/>
                    <a:pt x="837" y="704"/>
                  </a:cubicBezTo>
                  <a:cubicBezTo>
                    <a:pt x="853" y="709"/>
                    <a:pt x="885" y="720"/>
                    <a:pt x="885" y="720"/>
                  </a:cubicBezTo>
                  <a:cubicBezTo>
                    <a:pt x="903" y="747"/>
                    <a:pt x="923" y="754"/>
                    <a:pt x="933" y="784"/>
                  </a:cubicBezTo>
                  <a:cubicBezTo>
                    <a:pt x="930" y="797"/>
                    <a:pt x="933" y="813"/>
                    <a:pt x="925" y="824"/>
                  </a:cubicBezTo>
                  <a:cubicBezTo>
                    <a:pt x="920" y="831"/>
                    <a:pt x="909" y="828"/>
                    <a:pt x="901" y="832"/>
                  </a:cubicBezTo>
                  <a:cubicBezTo>
                    <a:pt x="847" y="859"/>
                    <a:pt x="814" y="856"/>
                    <a:pt x="757" y="872"/>
                  </a:cubicBezTo>
                  <a:cubicBezTo>
                    <a:pt x="731" y="880"/>
                    <a:pt x="685" y="912"/>
                    <a:pt x="685" y="912"/>
                  </a:cubicBezTo>
                  <a:cubicBezTo>
                    <a:pt x="644" y="974"/>
                    <a:pt x="685" y="1057"/>
                    <a:pt x="685" y="1128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Freeform 105"/>
            <p:cNvSpPr/>
            <p:nvPr/>
          </p:nvSpPr>
          <p:spPr>
            <a:xfrm>
              <a:off x="3565440" y="3364200"/>
              <a:ext cx="505080" cy="280440"/>
            </a:xfrm>
            <a:custGeom>
              <a:avLst/>
              <a:gdLst/>
              <a:ahLst/>
              <a:rect l="l" t="t" r="r" b="b"/>
              <a:pathLst>
                <a:path w="425" h="256">
                  <a:moveTo>
                    <a:pt x="48" y="0"/>
                  </a:moveTo>
                  <a:cubicBezTo>
                    <a:pt x="37" y="3"/>
                    <a:pt x="25" y="1"/>
                    <a:pt x="16" y="8"/>
                  </a:cubicBezTo>
                  <a:cubicBezTo>
                    <a:pt x="0" y="21"/>
                    <a:pt x="12" y="90"/>
                    <a:pt x="16" y="96"/>
                  </a:cubicBezTo>
                  <a:cubicBezTo>
                    <a:pt x="20" y="102"/>
                    <a:pt x="83" y="117"/>
                    <a:pt x="96" y="120"/>
                  </a:cubicBezTo>
                  <a:cubicBezTo>
                    <a:pt x="128" y="168"/>
                    <a:pt x="94" y="223"/>
                    <a:pt x="144" y="256"/>
                  </a:cubicBezTo>
                  <a:cubicBezTo>
                    <a:pt x="179" y="253"/>
                    <a:pt x="213" y="252"/>
                    <a:pt x="248" y="248"/>
                  </a:cubicBezTo>
                  <a:cubicBezTo>
                    <a:pt x="290" y="243"/>
                    <a:pt x="297" y="178"/>
                    <a:pt x="336" y="152"/>
                  </a:cubicBezTo>
                  <a:cubicBezTo>
                    <a:pt x="362" y="113"/>
                    <a:pt x="377" y="66"/>
                    <a:pt x="416" y="40"/>
                  </a:cubicBezTo>
                  <a:cubicBezTo>
                    <a:pt x="425" y="13"/>
                    <a:pt x="424" y="24"/>
                    <a:pt x="424" y="8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Freeform 106"/>
            <p:cNvSpPr/>
            <p:nvPr/>
          </p:nvSpPr>
          <p:spPr>
            <a:xfrm>
              <a:off x="2699280" y="3349080"/>
              <a:ext cx="447480" cy="85680"/>
            </a:xfrm>
            <a:custGeom>
              <a:avLst/>
              <a:gdLst/>
              <a:ahLst/>
              <a:rect l="l" t="t" r="r" b="b"/>
              <a:pathLst>
                <a:path w="376" h="78">
                  <a:moveTo>
                    <a:pt x="0" y="0"/>
                  </a:moveTo>
                  <a:cubicBezTo>
                    <a:pt x="16" y="65"/>
                    <a:pt x="66" y="43"/>
                    <a:pt x="136" y="48"/>
                  </a:cubicBezTo>
                  <a:cubicBezTo>
                    <a:pt x="202" y="46"/>
                    <a:pt x="376" y="78"/>
                    <a:pt x="376" y="8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Freeform 107"/>
            <p:cNvSpPr/>
            <p:nvPr/>
          </p:nvSpPr>
          <p:spPr>
            <a:xfrm>
              <a:off x="3147120" y="2510640"/>
              <a:ext cx="458280" cy="112320"/>
            </a:xfrm>
            <a:custGeom>
              <a:avLst/>
              <a:gdLst/>
              <a:ahLst/>
              <a:rect l="l" t="t" r="r" b="b"/>
              <a:pathLst>
                <a:path w="385" h="103">
                  <a:moveTo>
                    <a:pt x="0" y="103"/>
                  </a:moveTo>
                  <a:cubicBezTo>
                    <a:pt x="8" y="95"/>
                    <a:pt x="18" y="88"/>
                    <a:pt x="24" y="79"/>
                  </a:cubicBezTo>
                  <a:cubicBezTo>
                    <a:pt x="36" y="61"/>
                    <a:pt x="28" y="33"/>
                    <a:pt x="40" y="15"/>
                  </a:cubicBezTo>
                  <a:cubicBezTo>
                    <a:pt x="45" y="8"/>
                    <a:pt x="56" y="10"/>
                    <a:pt x="64" y="7"/>
                  </a:cubicBezTo>
                  <a:cubicBezTo>
                    <a:pt x="157" y="10"/>
                    <a:pt x="252" y="0"/>
                    <a:pt x="344" y="15"/>
                  </a:cubicBezTo>
                  <a:cubicBezTo>
                    <a:pt x="357" y="17"/>
                    <a:pt x="345" y="43"/>
                    <a:pt x="352" y="55"/>
                  </a:cubicBezTo>
                  <a:cubicBezTo>
                    <a:pt x="357" y="63"/>
                    <a:pt x="368" y="66"/>
                    <a:pt x="376" y="71"/>
                  </a:cubicBezTo>
                  <a:cubicBezTo>
                    <a:pt x="385" y="98"/>
                    <a:pt x="384" y="87"/>
                    <a:pt x="384" y="103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Freeform 108"/>
            <p:cNvSpPr/>
            <p:nvPr/>
          </p:nvSpPr>
          <p:spPr>
            <a:xfrm>
              <a:off x="4030920" y="2285280"/>
              <a:ext cx="511560" cy="355320"/>
            </a:xfrm>
            <a:custGeom>
              <a:avLst/>
              <a:gdLst/>
              <a:ahLst/>
              <a:rect l="l" t="t" r="r" b="b"/>
              <a:pathLst>
                <a:path w="430" h="325">
                  <a:moveTo>
                    <a:pt x="42" y="325"/>
                  </a:moveTo>
                  <a:cubicBezTo>
                    <a:pt x="31" y="250"/>
                    <a:pt x="0" y="83"/>
                    <a:pt x="90" y="53"/>
                  </a:cubicBezTo>
                  <a:cubicBezTo>
                    <a:pt x="189" y="56"/>
                    <a:pt x="324" y="0"/>
                    <a:pt x="386" y="77"/>
                  </a:cubicBezTo>
                  <a:cubicBezTo>
                    <a:pt x="430" y="132"/>
                    <a:pt x="349" y="71"/>
                    <a:pt x="418" y="117"/>
                  </a:cubicBezTo>
                  <a:cubicBezTo>
                    <a:pt x="429" y="150"/>
                    <a:pt x="428" y="162"/>
                    <a:pt x="394" y="173"/>
                  </a:cubicBezTo>
                  <a:cubicBezTo>
                    <a:pt x="370" y="209"/>
                    <a:pt x="343" y="257"/>
                    <a:pt x="402" y="277"/>
                  </a:cubicBezTo>
                  <a:cubicBezTo>
                    <a:pt x="421" y="305"/>
                    <a:pt x="418" y="291"/>
                    <a:pt x="418" y="317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Freeform 109"/>
            <p:cNvSpPr/>
            <p:nvPr/>
          </p:nvSpPr>
          <p:spPr>
            <a:xfrm>
              <a:off x="4538520" y="3346560"/>
              <a:ext cx="485640" cy="146520"/>
            </a:xfrm>
            <a:custGeom>
              <a:avLst/>
              <a:gdLst/>
              <a:ahLst/>
              <a:rect l="l" t="t" r="r" b="b"/>
              <a:pathLst>
                <a:path w="408" h="135">
                  <a:moveTo>
                    <a:pt x="0" y="11"/>
                  </a:moveTo>
                  <a:cubicBezTo>
                    <a:pt x="18" y="121"/>
                    <a:pt x="50" y="91"/>
                    <a:pt x="168" y="99"/>
                  </a:cubicBezTo>
                  <a:cubicBezTo>
                    <a:pt x="222" y="135"/>
                    <a:pt x="261" y="100"/>
                    <a:pt x="312" y="83"/>
                  </a:cubicBezTo>
                  <a:cubicBezTo>
                    <a:pt x="329" y="31"/>
                    <a:pt x="305" y="82"/>
                    <a:pt x="344" y="51"/>
                  </a:cubicBezTo>
                  <a:cubicBezTo>
                    <a:pt x="408" y="0"/>
                    <a:pt x="323" y="45"/>
                    <a:pt x="376" y="19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Freeform 110"/>
            <p:cNvSpPr/>
            <p:nvPr/>
          </p:nvSpPr>
          <p:spPr>
            <a:xfrm>
              <a:off x="3852000" y="1341720"/>
              <a:ext cx="2291760" cy="1290240"/>
            </a:xfrm>
            <a:custGeom>
              <a:avLst/>
              <a:gdLst/>
              <a:ahLst/>
              <a:rect l="l" t="t" r="r" b="b"/>
              <a:pathLst>
                <a:path w="1924" h="1180">
                  <a:moveTo>
                    <a:pt x="952" y="1172"/>
                  </a:moveTo>
                  <a:cubicBezTo>
                    <a:pt x="943" y="1078"/>
                    <a:pt x="921" y="1010"/>
                    <a:pt x="840" y="956"/>
                  </a:cubicBezTo>
                  <a:cubicBezTo>
                    <a:pt x="797" y="892"/>
                    <a:pt x="853" y="969"/>
                    <a:pt x="800" y="916"/>
                  </a:cubicBezTo>
                  <a:cubicBezTo>
                    <a:pt x="793" y="909"/>
                    <a:pt x="792" y="897"/>
                    <a:pt x="784" y="892"/>
                  </a:cubicBezTo>
                  <a:cubicBezTo>
                    <a:pt x="775" y="886"/>
                    <a:pt x="763" y="887"/>
                    <a:pt x="752" y="884"/>
                  </a:cubicBezTo>
                  <a:cubicBezTo>
                    <a:pt x="707" y="816"/>
                    <a:pt x="642" y="789"/>
                    <a:pt x="568" y="764"/>
                  </a:cubicBezTo>
                  <a:cubicBezTo>
                    <a:pt x="541" y="755"/>
                    <a:pt x="528" y="760"/>
                    <a:pt x="504" y="748"/>
                  </a:cubicBezTo>
                  <a:cubicBezTo>
                    <a:pt x="449" y="720"/>
                    <a:pt x="391" y="696"/>
                    <a:pt x="336" y="668"/>
                  </a:cubicBezTo>
                  <a:cubicBezTo>
                    <a:pt x="284" y="642"/>
                    <a:pt x="341" y="663"/>
                    <a:pt x="288" y="628"/>
                  </a:cubicBezTo>
                  <a:cubicBezTo>
                    <a:pt x="265" y="613"/>
                    <a:pt x="239" y="603"/>
                    <a:pt x="216" y="588"/>
                  </a:cubicBezTo>
                  <a:cubicBezTo>
                    <a:pt x="200" y="577"/>
                    <a:pt x="168" y="556"/>
                    <a:pt x="168" y="556"/>
                  </a:cubicBezTo>
                  <a:cubicBezTo>
                    <a:pt x="130" y="499"/>
                    <a:pt x="150" y="522"/>
                    <a:pt x="112" y="484"/>
                  </a:cubicBezTo>
                  <a:cubicBezTo>
                    <a:pt x="106" y="467"/>
                    <a:pt x="93" y="453"/>
                    <a:pt x="88" y="436"/>
                  </a:cubicBezTo>
                  <a:cubicBezTo>
                    <a:pt x="67" y="360"/>
                    <a:pt x="92" y="376"/>
                    <a:pt x="40" y="324"/>
                  </a:cubicBezTo>
                  <a:cubicBezTo>
                    <a:pt x="32" y="300"/>
                    <a:pt x="24" y="276"/>
                    <a:pt x="16" y="252"/>
                  </a:cubicBezTo>
                  <a:cubicBezTo>
                    <a:pt x="11" y="236"/>
                    <a:pt x="0" y="204"/>
                    <a:pt x="0" y="204"/>
                  </a:cubicBezTo>
                  <a:cubicBezTo>
                    <a:pt x="13" y="20"/>
                    <a:pt x="12" y="75"/>
                    <a:pt x="232" y="84"/>
                  </a:cubicBezTo>
                  <a:cubicBezTo>
                    <a:pt x="269" y="96"/>
                    <a:pt x="259" y="108"/>
                    <a:pt x="280" y="140"/>
                  </a:cubicBezTo>
                  <a:cubicBezTo>
                    <a:pt x="283" y="194"/>
                    <a:pt x="259" y="280"/>
                    <a:pt x="320" y="300"/>
                  </a:cubicBezTo>
                  <a:cubicBezTo>
                    <a:pt x="347" y="297"/>
                    <a:pt x="374" y="298"/>
                    <a:pt x="400" y="292"/>
                  </a:cubicBezTo>
                  <a:cubicBezTo>
                    <a:pt x="443" y="282"/>
                    <a:pt x="458" y="213"/>
                    <a:pt x="496" y="188"/>
                  </a:cubicBezTo>
                  <a:cubicBezTo>
                    <a:pt x="515" y="131"/>
                    <a:pt x="503" y="154"/>
                    <a:pt x="528" y="116"/>
                  </a:cubicBezTo>
                  <a:cubicBezTo>
                    <a:pt x="571" y="130"/>
                    <a:pt x="585" y="157"/>
                    <a:pt x="616" y="188"/>
                  </a:cubicBezTo>
                  <a:cubicBezTo>
                    <a:pt x="655" y="306"/>
                    <a:pt x="566" y="505"/>
                    <a:pt x="720" y="556"/>
                  </a:cubicBezTo>
                  <a:cubicBezTo>
                    <a:pt x="790" y="550"/>
                    <a:pt x="814" y="557"/>
                    <a:pt x="864" y="524"/>
                  </a:cubicBezTo>
                  <a:cubicBezTo>
                    <a:pt x="882" y="470"/>
                    <a:pt x="857" y="529"/>
                    <a:pt x="896" y="484"/>
                  </a:cubicBezTo>
                  <a:cubicBezTo>
                    <a:pt x="909" y="470"/>
                    <a:pt x="917" y="452"/>
                    <a:pt x="928" y="436"/>
                  </a:cubicBezTo>
                  <a:cubicBezTo>
                    <a:pt x="933" y="428"/>
                    <a:pt x="944" y="412"/>
                    <a:pt x="944" y="412"/>
                  </a:cubicBezTo>
                  <a:cubicBezTo>
                    <a:pt x="972" y="299"/>
                    <a:pt x="959" y="370"/>
                    <a:pt x="968" y="196"/>
                  </a:cubicBezTo>
                  <a:cubicBezTo>
                    <a:pt x="1002" y="219"/>
                    <a:pt x="1015" y="246"/>
                    <a:pt x="1056" y="260"/>
                  </a:cubicBezTo>
                  <a:cubicBezTo>
                    <a:pt x="1064" y="305"/>
                    <a:pt x="1059" y="323"/>
                    <a:pt x="1096" y="348"/>
                  </a:cubicBezTo>
                  <a:cubicBezTo>
                    <a:pt x="1140" y="342"/>
                    <a:pt x="1170" y="350"/>
                    <a:pt x="1184" y="308"/>
                  </a:cubicBezTo>
                  <a:cubicBezTo>
                    <a:pt x="1182" y="287"/>
                    <a:pt x="1184" y="221"/>
                    <a:pt x="1168" y="188"/>
                  </a:cubicBezTo>
                  <a:cubicBezTo>
                    <a:pt x="1156" y="165"/>
                    <a:pt x="1136" y="116"/>
                    <a:pt x="1136" y="116"/>
                  </a:cubicBezTo>
                  <a:cubicBezTo>
                    <a:pt x="1145" y="73"/>
                    <a:pt x="1148" y="60"/>
                    <a:pt x="1184" y="36"/>
                  </a:cubicBezTo>
                  <a:cubicBezTo>
                    <a:pt x="1468" y="44"/>
                    <a:pt x="1387" y="0"/>
                    <a:pt x="1512" y="84"/>
                  </a:cubicBezTo>
                  <a:cubicBezTo>
                    <a:pt x="1520" y="248"/>
                    <a:pt x="1478" y="263"/>
                    <a:pt x="1584" y="228"/>
                  </a:cubicBezTo>
                  <a:cubicBezTo>
                    <a:pt x="1614" y="198"/>
                    <a:pt x="1629" y="163"/>
                    <a:pt x="1664" y="140"/>
                  </a:cubicBezTo>
                  <a:cubicBezTo>
                    <a:pt x="1699" y="143"/>
                    <a:pt x="1734" y="142"/>
                    <a:pt x="1768" y="148"/>
                  </a:cubicBezTo>
                  <a:cubicBezTo>
                    <a:pt x="1795" y="153"/>
                    <a:pt x="1806" y="185"/>
                    <a:pt x="1848" y="196"/>
                  </a:cubicBezTo>
                  <a:cubicBezTo>
                    <a:pt x="1887" y="222"/>
                    <a:pt x="1892" y="203"/>
                    <a:pt x="1904" y="252"/>
                  </a:cubicBezTo>
                  <a:cubicBezTo>
                    <a:pt x="1901" y="276"/>
                    <a:pt x="1905" y="302"/>
                    <a:pt x="1896" y="324"/>
                  </a:cubicBezTo>
                  <a:cubicBezTo>
                    <a:pt x="1894" y="328"/>
                    <a:pt x="1838" y="349"/>
                    <a:pt x="1824" y="356"/>
                  </a:cubicBezTo>
                  <a:cubicBezTo>
                    <a:pt x="1771" y="382"/>
                    <a:pt x="1713" y="388"/>
                    <a:pt x="1656" y="404"/>
                  </a:cubicBezTo>
                  <a:cubicBezTo>
                    <a:pt x="1628" y="412"/>
                    <a:pt x="1601" y="421"/>
                    <a:pt x="1576" y="436"/>
                  </a:cubicBezTo>
                  <a:cubicBezTo>
                    <a:pt x="1560" y="446"/>
                    <a:pt x="1528" y="468"/>
                    <a:pt x="1528" y="468"/>
                  </a:cubicBezTo>
                  <a:cubicBezTo>
                    <a:pt x="1517" y="501"/>
                    <a:pt x="1518" y="513"/>
                    <a:pt x="1552" y="524"/>
                  </a:cubicBezTo>
                  <a:cubicBezTo>
                    <a:pt x="1562" y="523"/>
                    <a:pt x="1637" y="523"/>
                    <a:pt x="1664" y="508"/>
                  </a:cubicBezTo>
                  <a:cubicBezTo>
                    <a:pt x="1747" y="462"/>
                    <a:pt x="1682" y="486"/>
                    <a:pt x="1736" y="468"/>
                  </a:cubicBezTo>
                  <a:cubicBezTo>
                    <a:pt x="1765" y="471"/>
                    <a:pt x="1796" y="468"/>
                    <a:pt x="1824" y="476"/>
                  </a:cubicBezTo>
                  <a:cubicBezTo>
                    <a:pt x="1869" y="489"/>
                    <a:pt x="1906" y="539"/>
                    <a:pt x="1920" y="580"/>
                  </a:cubicBezTo>
                  <a:cubicBezTo>
                    <a:pt x="1917" y="609"/>
                    <a:pt x="1924" y="641"/>
                    <a:pt x="1912" y="668"/>
                  </a:cubicBezTo>
                  <a:cubicBezTo>
                    <a:pt x="1904" y="685"/>
                    <a:pt x="1882" y="694"/>
                    <a:pt x="1864" y="700"/>
                  </a:cubicBezTo>
                  <a:cubicBezTo>
                    <a:pt x="1800" y="721"/>
                    <a:pt x="1736" y="740"/>
                    <a:pt x="1672" y="756"/>
                  </a:cubicBezTo>
                  <a:cubicBezTo>
                    <a:pt x="1630" y="767"/>
                    <a:pt x="1585" y="782"/>
                    <a:pt x="1544" y="796"/>
                  </a:cubicBezTo>
                  <a:cubicBezTo>
                    <a:pt x="1528" y="801"/>
                    <a:pt x="1496" y="812"/>
                    <a:pt x="1496" y="812"/>
                  </a:cubicBezTo>
                  <a:cubicBezTo>
                    <a:pt x="1464" y="844"/>
                    <a:pt x="1437" y="875"/>
                    <a:pt x="1400" y="900"/>
                  </a:cubicBezTo>
                  <a:cubicBezTo>
                    <a:pt x="1395" y="908"/>
                    <a:pt x="1392" y="918"/>
                    <a:pt x="1384" y="924"/>
                  </a:cubicBezTo>
                  <a:cubicBezTo>
                    <a:pt x="1377" y="929"/>
                    <a:pt x="1366" y="926"/>
                    <a:pt x="1360" y="932"/>
                  </a:cubicBezTo>
                  <a:cubicBezTo>
                    <a:pt x="1339" y="953"/>
                    <a:pt x="1325" y="983"/>
                    <a:pt x="1304" y="1004"/>
                  </a:cubicBezTo>
                  <a:cubicBezTo>
                    <a:pt x="1283" y="1066"/>
                    <a:pt x="1289" y="1064"/>
                    <a:pt x="1304" y="1132"/>
                  </a:cubicBezTo>
                  <a:cubicBezTo>
                    <a:pt x="1308" y="1148"/>
                    <a:pt x="1312" y="1180"/>
                    <a:pt x="1312" y="1180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Freeform 111"/>
            <p:cNvSpPr/>
            <p:nvPr/>
          </p:nvSpPr>
          <p:spPr>
            <a:xfrm>
              <a:off x="5442480" y="3353400"/>
              <a:ext cx="467280" cy="65880"/>
            </a:xfrm>
            <a:custGeom>
              <a:avLst/>
              <a:gdLst/>
              <a:ahLst/>
              <a:rect l="l" t="t" r="r" b="b"/>
              <a:pathLst>
                <a:path w="392" h="60">
                  <a:moveTo>
                    <a:pt x="0" y="4"/>
                  </a:moveTo>
                  <a:cubicBezTo>
                    <a:pt x="47" y="20"/>
                    <a:pt x="4" y="0"/>
                    <a:pt x="40" y="36"/>
                  </a:cubicBezTo>
                  <a:cubicBezTo>
                    <a:pt x="58" y="54"/>
                    <a:pt x="72" y="54"/>
                    <a:pt x="96" y="60"/>
                  </a:cubicBezTo>
                  <a:cubicBezTo>
                    <a:pt x="187" y="47"/>
                    <a:pt x="265" y="41"/>
                    <a:pt x="360" y="36"/>
                  </a:cubicBezTo>
                  <a:cubicBezTo>
                    <a:pt x="368" y="33"/>
                    <a:pt x="378" y="34"/>
                    <a:pt x="384" y="28"/>
                  </a:cubicBezTo>
                  <a:cubicBezTo>
                    <a:pt x="390" y="22"/>
                    <a:pt x="392" y="4"/>
                    <a:pt x="392" y="4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080" bIns="19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Freeform 112"/>
            <p:cNvSpPr/>
            <p:nvPr/>
          </p:nvSpPr>
          <p:spPr>
            <a:xfrm>
              <a:off x="5862240" y="2316960"/>
              <a:ext cx="528840" cy="323640"/>
            </a:xfrm>
            <a:custGeom>
              <a:avLst/>
              <a:gdLst/>
              <a:ahLst/>
              <a:rect l="l" t="t" r="r" b="b"/>
              <a:pathLst>
                <a:path w="444" h="296">
                  <a:moveTo>
                    <a:pt x="24" y="288"/>
                  </a:moveTo>
                  <a:cubicBezTo>
                    <a:pt x="0" y="216"/>
                    <a:pt x="6" y="254"/>
                    <a:pt x="16" y="160"/>
                  </a:cubicBezTo>
                  <a:cubicBezTo>
                    <a:pt x="20" y="128"/>
                    <a:pt x="14" y="91"/>
                    <a:pt x="32" y="64"/>
                  </a:cubicBezTo>
                  <a:cubicBezTo>
                    <a:pt x="52" y="34"/>
                    <a:pt x="118" y="27"/>
                    <a:pt x="152" y="16"/>
                  </a:cubicBezTo>
                  <a:cubicBezTo>
                    <a:pt x="168" y="11"/>
                    <a:pt x="200" y="0"/>
                    <a:pt x="200" y="0"/>
                  </a:cubicBezTo>
                  <a:cubicBezTo>
                    <a:pt x="261" y="6"/>
                    <a:pt x="283" y="2"/>
                    <a:pt x="328" y="32"/>
                  </a:cubicBezTo>
                  <a:cubicBezTo>
                    <a:pt x="347" y="61"/>
                    <a:pt x="364" y="61"/>
                    <a:pt x="392" y="80"/>
                  </a:cubicBezTo>
                  <a:cubicBezTo>
                    <a:pt x="444" y="157"/>
                    <a:pt x="408" y="94"/>
                    <a:pt x="408" y="296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Freeform 113"/>
            <p:cNvSpPr/>
            <p:nvPr/>
          </p:nvSpPr>
          <p:spPr>
            <a:xfrm>
              <a:off x="6336720" y="3366720"/>
              <a:ext cx="126360" cy="227160"/>
            </a:xfrm>
            <a:custGeom>
              <a:avLst/>
              <a:gdLst/>
              <a:ahLst/>
              <a:rect l="l" t="t" r="r" b="b"/>
              <a:pathLst>
                <a:path w="106" h="208">
                  <a:moveTo>
                    <a:pt x="34" y="0"/>
                  </a:moveTo>
                  <a:cubicBezTo>
                    <a:pt x="6" y="83"/>
                    <a:pt x="0" y="208"/>
                    <a:pt x="106" y="208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Text Box 114"/>
            <p:cNvSpPr/>
            <p:nvPr/>
          </p:nvSpPr>
          <p:spPr>
            <a:xfrm>
              <a:off x="3994920" y="2173680"/>
              <a:ext cx="1060200" cy="200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000" rIns="63000" tIns="31680" bIns="3168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9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Loop No. 6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08T04:07:36Z</dcterms:created>
  <dc:creator>Anesh Nair</dc:creator>
  <dc:description/>
  <dc:language>en-US</dc:language>
  <cp:lastModifiedBy>Anesh</cp:lastModifiedBy>
  <dcterms:modified xsi:type="dcterms:W3CDTF">2011-12-08T23:44:10Z</dcterms:modified>
  <cp:revision>4</cp:revision>
  <dc:subject/>
  <dc:title>PowerPoint Presentation</dc:title>
</cp:coreProperties>
</file>